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97"/>
    <p:restoredTop sz="94646"/>
  </p:normalViewPr>
  <p:slideViewPr>
    <p:cSldViewPr snapToGrid="0" snapToObjects="1">
      <p:cViewPr varScale="1">
        <p:scale>
          <a:sx n="102" d="100"/>
          <a:sy n="102" d="100"/>
        </p:scale>
        <p:origin x="20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 20">
            <a:extLst>
              <a:ext uri="{FF2B5EF4-FFF2-40B4-BE49-F238E27FC236}">
                <a16:creationId xmlns:a16="http://schemas.microsoft.com/office/drawing/2014/main" id="{EB3CC829-77DA-1C4E-BF55-92AF9D2915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2653" y="4026088"/>
            <a:ext cx="2447835" cy="2457453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9896980E-EA9D-B84B-BF80-D9FF19B7E3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3444" y="4026089"/>
            <a:ext cx="2438254" cy="2447835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301914C5-C5C9-9A48-8388-6EB8D229B7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12654" y="1433015"/>
            <a:ext cx="2447835" cy="2447835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B282A0F8-472E-4D47-989D-CD6B2179DF3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3444" y="1433016"/>
            <a:ext cx="2438254" cy="244304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express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mo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/Igf-1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lacti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growt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B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localisatio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FLAG-Gpr101 and Pit-1 in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9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n=4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nimal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at least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3112655" y="40260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483445" y="4026089"/>
            <a:ext cx="19543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t-1 </a:t>
            </a:r>
          </a:p>
          <a:p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A091BE7-7575-6E4E-A30D-B5E989C1ABA3}"/>
              </a:ext>
            </a:extLst>
          </p:cNvPr>
          <p:cNvSpPr/>
          <p:nvPr/>
        </p:nvSpPr>
        <p:spPr>
          <a:xfrm>
            <a:off x="5751446" y="4899473"/>
            <a:ext cx="6096000" cy="163121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Pit-1 (anterior pituitary)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rabbit anti-Pit1 (Novus Biologicals, Cat. </a:t>
            </a:r>
            <a:r>
              <a:rPr lang="en-US" sz="160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No NBP1-92273, dilution 1:500) </a:t>
            </a:r>
            <a:r>
              <a:rPr lang="fr-BE" sz="160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fr-BE" sz="1600" dirty="0">
              <a:solidFill>
                <a:srgbClr val="FF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+L) F(ab’)2 fragment Alexa Fluor 647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chnolog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at. No 4414, dilution 1:1000)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751446" y="1550369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751446" y="2748816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 IgG Fab2 Alexa Fluor 488 conjugate (Cell Signaling Technology, Cat. No 4408S, dilution 1:1000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215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10</cp:revision>
  <dcterms:created xsi:type="dcterms:W3CDTF">2020-05-09T12:35:08Z</dcterms:created>
  <dcterms:modified xsi:type="dcterms:W3CDTF">2020-05-25T16:53:10Z</dcterms:modified>
</cp:coreProperties>
</file>